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5" d="100"/>
          <a:sy n="55" d="100"/>
        </p:scale>
        <p:origin x="15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DIRHome\harbisonst\Aim%20I%20Artificial%20Selection\Sleep%20Deprivation%20of%20Populations%20and%20Minos%20Lines\Minos%2024hour%20and%20day%20sleep%20duration%20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DIRHome\harbisonst\Aim%20I%20Artificial%20Selection\Sleep%20Deprivation%20of%20Populations%20and%20Minos%20Lines\Minos%2024hour%20and%20day%20sleep%20duration%20plo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ifferences!$D$1</c:f>
              <c:strCache>
                <c:ptCount val="1"/>
                <c:pt idx="0">
                  <c:v>Mean(sleep24_diff_dep)</c:v>
                </c:pt>
              </c:strCache>
            </c:strRef>
          </c:tx>
          <c:spPr>
            <a:solidFill>
              <a:srgbClr val="666699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G$2:$G$5</c:f>
                <c:numCache>
                  <c:formatCode>General</c:formatCode>
                  <c:ptCount val="4"/>
                  <c:pt idx="0">
                    <c:v>15.757506428999999</c:v>
                  </c:pt>
                  <c:pt idx="1">
                    <c:v>12.496107050999999</c:v>
                  </c:pt>
                  <c:pt idx="2">
                    <c:v>14.675485359</c:v>
                  </c:pt>
                  <c:pt idx="3">
                    <c:v>19.001218367</c:v>
                  </c:pt>
                </c:numCache>
              </c:numRef>
            </c:plus>
            <c:minus>
              <c:numRef>
                <c:f>Differences!$G$2:$G$5</c:f>
                <c:numCache>
                  <c:formatCode>General</c:formatCode>
                  <c:ptCount val="4"/>
                  <c:pt idx="0">
                    <c:v>15.757506428999999</c:v>
                  </c:pt>
                  <c:pt idx="1">
                    <c:v>12.496107050999999</c:v>
                  </c:pt>
                  <c:pt idx="2">
                    <c:v>14.675485359</c:v>
                  </c:pt>
                  <c:pt idx="3">
                    <c:v>19.00121836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2:$A$5</c:f>
              <c:strCache>
                <c:ptCount val="4"/>
                <c:pt idx="0">
                  <c:v>CG33156</c:v>
                </c:pt>
                <c:pt idx="1">
                  <c:v>fz</c:v>
                </c:pt>
                <c:pt idx="2">
                  <c:v>sgg</c:v>
                </c:pt>
                <c:pt idx="3">
                  <c:v>w1118[5905]</c:v>
                </c:pt>
              </c:strCache>
            </c:strRef>
          </c:cat>
          <c:val>
            <c:numRef>
              <c:f>Differences!$D$2:$D$5</c:f>
              <c:numCache>
                <c:formatCode>General</c:formatCode>
                <c:ptCount val="4"/>
                <c:pt idx="0">
                  <c:v>70.095238094999999</c:v>
                </c:pt>
                <c:pt idx="1">
                  <c:v>51.769841270000001</c:v>
                </c:pt>
                <c:pt idx="2">
                  <c:v>50.809523810000002</c:v>
                </c:pt>
                <c:pt idx="3">
                  <c:v>5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0D-4FDA-A4F3-8588DC324BC7}"/>
            </c:ext>
          </c:extLst>
        </c:ser>
        <c:ser>
          <c:idx val="1"/>
          <c:order val="1"/>
          <c:tx>
            <c:strRef>
              <c:f>Differences!$E$1</c:f>
              <c:strCache>
                <c:ptCount val="1"/>
                <c:pt idx="0">
                  <c:v>Mean(sleep24_diff_reb)</c:v>
                </c:pt>
              </c:strCache>
            </c:strRef>
          </c:tx>
          <c:spPr>
            <a:solidFill>
              <a:srgbClr val="9999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H$2:$H$5</c:f>
                <c:numCache>
                  <c:formatCode>General</c:formatCode>
                  <c:ptCount val="4"/>
                  <c:pt idx="0">
                    <c:v>16.995030321000002</c:v>
                  </c:pt>
                  <c:pt idx="1">
                    <c:v>15.006206368000001</c:v>
                  </c:pt>
                  <c:pt idx="2">
                    <c:v>16.172502900000001</c:v>
                  </c:pt>
                  <c:pt idx="3">
                    <c:v>20.346671668999999</c:v>
                  </c:pt>
                </c:numCache>
              </c:numRef>
            </c:plus>
            <c:minus>
              <c:numRef>
                <c:f>Differences!$H$2:$H$5</c:f>
                <c:numCache>
                  <c:formatCode>General</c:formatCode>
                  <c:ptCount val="4"/>
                  <c:pt idx="0">
                    <c:v>16.995030321000002</c:v>
                  </c:pt>
                  <c:pt idx="1">
                    <c:v>15.006206368000001</c:v>
                  </c:pt>
                  <c:pt idx="2">
                    <c:v>16.172502900000001</c:v>
                  </c:pt>
                  <c:pt idx="3">
                    <c:v>20.3466716689999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2:$A$5</c:f>
              <c:strCache>
                <c:ptCount val="4"/>
                <c:pt idx="0">
                  <c:v>CG33156</c:v>
                </c:pt>
                <c:pt idx="1">
                  <c:v>fz</c:v>
                </c:pt>
                <c:pt idx="2">
                  <c:v>sgg</c:v>
                </c:pt>
                <c:pt idx="3">
                  <c:v>w1118[5905]</c:v>
                </c:pt>
              </c:strCache>
            </c:strRef>
          </c:cat>
          <c:val>
            <c:numRef>
              <c:f>Differences!$E$2:$E$5</c:f>
              <c:numCache>
                <c:formatCode>General</c:formatCode>
                <c:ptCount val="4"/>
                <c:pt idx="0">
                  <c:v>30.634920635</c:v>
                </c:pt>
                <c:pt idx="1">
                  <c:v>20.658730159000001</c:v>
                </c:pt>
                <c:pt idx="2">
                  <c:v>92.857142856999999</c:v>
                </c:pt>
                <c:pt idx="3">
                  <c:v>107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0D-4FDA-A4F3-8588DC324B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0903128"/>
        <c:axId val="310907392"/>
      </c:barChart>
      <c:catAx>
        <c:axId val="310903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0907392"/>
        <c:crosses val="autoZero"/>
        <c:auto val="1"/>
        <c:lblAlgn val="ctr"/>
        <c:lblOffset val="100"/>
        <c:noMultiLvlLbl val="0"/>
      </c:catAx>
      <c:valAx>
        <c:axId val="310907392"/>
        <c:scaling>
          <c:orientation val="minMax"/>
          <c:max val="400"/>
          <c:min val="-4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0903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ifferences!$F$1</c:f>
              <c:strCache>
                <c:ptCount val="1"/>
                <c:pt idx="0">
                  <c:v>Mean(sleepd_diff_reb)</c:v>
                </c:pt>
              </c:strCache>
            </c:strRef>
          </c:tx>
          <c:spPr>
            <a:solidFill>
              <a:srgbClr val="9999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I$2:$I$5</c:f>
                <c:numCache>
                  <c:formatCode>General</c:formatCode>
                  <c:ptCount val="4"/>
                  <c:pt idx="0">
                    <c:v>7.9795922212999999</c:v>
                  </c:pt>
                  <c:pt idx="1">
                    <c:v>9.7339092947000001</c:v>
                  </c:pt>
                  <c:pt idx="2">
                    <c:v>8.9627172075000008</c:v>
                  </c:pt>
                  <c:pt idx="3">
                    <c:v>9.6290579530000002</c:v>
                  </c:pt>
                </c:numCache>
              </c:numRef>
            </c:plus>
            <c:minus>
              <c:numRef>
                <c:f>Differences!$I$2:$I$5</c:f>
                <c:numCache>
                  <c:formatCode>General</c:formatCode>
                  <c:ptCount val="4"/>
                  <c:pt idx="0">
                    <c:v>7.9795922212999999</c:v>
                  </c:pt>
                  <c:pt idx="1">
                    <c:v>9.7339092947000001</c:v>
                  </c:pt>
                  <c:pt idx="2">
                    <c:v>8.9627172075000008</c:v>
                  </c:pt>
                  <c:pt idx="3">
                    <c:v>9.629057953000000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2:$A$5</c:f>
              <c:strCache>
                <c:ptCount val="4"/>
                <c:pt idx="0">
                  <c:v>CG33156</c:v>
                </c:pt>
                <c:pt idx="1">
                  <c:v>fz</c:v>
                </c:pt>
                <c:pt idx="2">
                  <c:v>sgg</c:v>
                </c:pt>
                <c:pt idx="3">
                  <c:v>w1118[5905]</c:v>
                </c:pt>
              </c:strCache>
            </c:strRef>
          </c:cat>
          <c:val>
            <c:numRef>
              <c:f>Differences!$F$2:$F$5</c:f>
              <c:numCache>
                <c:formatCode>General</c:formatCode>
                <c:ptCount val="4"/>
                <c:pt idx="0">
                  <c:v>20.611111111</c:v>
                </c:pt>
                <c:pt idx="1">
                  <c:v>29.444444443999998</c:v>
                </c:pt>
                <c:pt idx="2">
                  <c:v>28.182539683000002</c:v>
                </c:pt>
                <c:pt idx="3">
                  <c:v>5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F1-4DAE-9316-E4723F1AE1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3827592"/>
        <c:axId val="473822672"/>
      </c:barChart>
      <c:catAx>
        <c:axId val="473827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3822672"/>
        <c:crosses val="autoZero"/>
        <c:auto val="1"/>
        <c:lblAlgn val="ctr"/>
        <c:lblOffset val="100"/>
        <c:noMultiLvlLbl val="0"/>
      </c:catAx>
      <c:valAx>
        <c:axId val="473822672"/>
        <c:scaling>
          <c:orientation val="minMax"/>
          <c:max val="2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3827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7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930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59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115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769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027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108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543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872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351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32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0817C-7B44-4DA8-8EAC-EF9564597AEA}" type="datetimeFigureOut">
              <a:rPr lang="en-US" smtClean="0"/>
              <a:t>10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884D5-2A30-47A3-82E9-37F3E6A62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632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882359" y="1756487"/>
            <a:ext cx="3153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ifference in 24-hour sleep over baseline (min.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8812" y="438028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4003" y="13357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743058" y="6392965"/>
            <a:ext cx="2874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ifference in day sleep over baseline (min.)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CD7D270C-2362-4B7C-9E1F-EA02B35EEEE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920562164"/>
              </p:ext>
            </p:extLst>
          </p:nvPr>
        </p:nvGraphicFramePr>
        <p:xfrm>
          <a:off x="969264" y="320041"/>
          <a:ext cx="5029200" cy="3645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328139" y="134098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998785" y="161798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59BE6C62-ACAF-4273-86E1-454E3073350B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83322168"/>
              </p:ext>
            </p:extLst>
          </p:nvPr>
        </p:nvGraphicFramePr>
        <p:xfrm>
          <a:off x="969264" y="4754880"/>
          <a:ext cx="5029200" cy="3645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5175504" y="683911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718869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3</Words>
  <Application>Microsoft Office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2</cp:revision>
  <dcterms:created xsi:type="dcterms:W3CDTF">2017-10-29T17:16:55Z</dcterms:created>
  <dcterms:modified xsi:type="dcterms:W3CDTF">2017-10-29T17:34:07Z</dcterms:modified>
</cp:coreProperties>
</file>